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123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932F44-2D7C-4F0D-A7F9-FF7B116E49E7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0BE752-9C66-49E3-B2E1-FDCDAFADEAA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1" name="幻灯片图像占位符 1"/>
          <p:cNvSpPr>
            <a:spLocks noGrp="1" noRot="1" noChangeAspect="1" noChangeArrowheads="1" noTextEdit="1"/>
          </p:cNvSpPr>
          <p:nvPr>
            <p:ph type="sldImg" idx="4294967295"/>
          </p:nvPr>
        </p:nvSpPr>
        <p:spPr bwMode="auto"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0482" name="文本占位符 2"/>
          <p:cNvSpPr>
            <a:spLocks noGrp="1" noChangeArrowheads="1"/>
          </p:cNvSpPr>
          <p:nvPr>
            <p:ph type="body" idx="4294967295"/>
          </p:nvPr>
        </p:nvSpPr>
        <p:spPr bwMode="auto">
          <a:noFill/>
          <a:ln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zh-CN" smtClean="0">
                <a:latin typeface="Arial" pitchFamily="34" charset="0"/>
              </a:rPr>
              <a:t>Tab. S1.</a:t>
            </a:r>
            <a:r>
              <a:rPr lang="en-US" altLang="zh-CN" smtClean="0"/>
              <a:t> qPCR primer information.</a:t>
            </a: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29" name="幻灯片图像占位符 1"/>
          <p:cNvSpPr>
            <a:spLocks noGrp="1" noRot="1" noChangeAspect="1" noChangeArrowheads="1" noTextEdit="1"/>
          </p:cNvSpPr>
          <p:nvPr>
            <p:ph type="sldImg" idx="4294967295"/>
          </p:nvPr>
        </p:nvSpPr>
        <p:spPr bwMode="auto"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2530" name="备注占位符 2"/>
          <p:cNvSpPr>
            <a:spLocks noGrp="1" noChangeArrowheads="1"/>
          </p:cNvSpPr>
          <p:nvPr>
            <p:ph type="body" idx="4294967295"/>
          </p:nvPr>
        </p:nvSpPr>
        <p:spPr bwMode="auto">
          <a:noFill/>
          <a:ln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zh-CN" smtClean="0"/>
              <a:t>Tab. S2. Sequencing data statistic results.</a:t>
            </a:r>
            <a:endParaRPr lang="zh-CN" altLang="en-US" smtClean="0"/>
          </a:p>
        </p:txBody>
      </p:sp>
      <p:sp>
        <p:nvSpPr>
          <p:cNvPr id="22531" name="灯片编号占位符 3"/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/>
          <a:lstStyle/>
          <a:p>
            <a:fld id="{72B057A9-97CF-4E6C-AA0E-C36029AFA13B}" type="slidenum">
              <a:rPr lang="zh-CN" altLang="en-US"/>
              <a:pPr/>
              <a:t>2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幻灯片图像占位符 1"/>
          <p:cNvSpPr>
            <a:spLocks noGrp="1" noRot="1" noChangeAspect="1" noChangeArrowheads="1" noTextEdit="1"/>
          </p:cNvSpPr>
          <p:nvPr>
            <p:ph type="sldImg" idx="4294967295"/>
          </p:nvPr>
        </p:nvSpPr>
        <p:spPr bwMode="auto"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4578" name="备注占位符 2"/>
          <p:cNvSpPr>
            <a:spLocks noGrp="1" noChangeArrowheads="1"/>
          </p:cNvSpPr>
          <p:nvPr>
            <p:ph type="body" idx="4294967295"/>
          </p:nvPr>
        </p:nvSpPr>
        <p:spPr bwMode="auto">
          <a:noFill/>
          <a:ln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zh-CN" smtClean="0"/>
              <a:t>Tab. S3. Aligment data statistic results.</a:t>
            </a:r>
            <a:endParaRPr lang="zh-CN" altLang="en-US" smtClean="0"/>
          </a:p>
        </p:txBody>
      </p:sp>
      <p:sp>
        <p:nvSpPr>
          <p:cNvPr id="24579" name="灯片编号占位符 3"/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/>
          <a:lstStyle/>
          <a:p>
            <a:fld id="{46817645-C16A-455F-A242-48119F79476F}" type="slidenum">
              <a:rPr lang="zh-CN" altLang="en-US"/>
              <a:pPr/>
              <a:t>3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5" name="幻灯片图像占位符 1"/>
          <p:cNvSpPr>
            <a:spLocks noGrp="1" noRot="1" noChangeAspect="1" noChangeArrowheads="1" noTextEdit="1"/>
          </p:cNvSpPr>
          <p:nvPr>
            <p:ph type="sldImg" idx="4294967295"/>
          </p:nvPr>
        </p:nvSpPr>
        <p:spPr bwMode="auto"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6626" name="备注占位符 2"/>
          <p:cNvSpPr>
            <a:spLocks noGrp="1" noChangeArrowheads="1"/>
          </p:cNvSpPr>
          <p:nvPr>
            <p:ph type="body" idx="4294967295"/>
          </p:nvPr>
        </p:nvSpPr>
        <p:spPr bwMode="auto">
          <a:noFill/>
          <a:ln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zh-CN" smtClean="0"/>
              <a:t> Tab. S4. Apoptosis</a:t>
            </a:r>
            <a:r>
              <a:rPr lang="zh-CN" altLang="en-US" smtClean="0"/>
              <a:t>-related </a:t>
            </a:r>
            <a:r>
              <a:rPr lang="en-US" altLang="zh-CN" smtClean="0"/>
              <a:t>secreted factors induced by Ctrl-hMSCs and ISL1-hMSCs. </a:t>
            </a:r>
          </a:p>
        </p:txBody>
      </p:sp>
      <p:sp>
        <p:nvSpPr>
          <p:cNvPr id="26627" name="灯片编号占位符 3"/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/>
          <a:lstStyle/>
          <a:p>
            <a:fld id="{B5017171-F0DF-48AE-9068-253405FA9D07}" type="slidenum">
              <a:rPr lang="zh-CN" altLang="en-US"/>
              <a:pPr/>
              <a:t>4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D6D14-15CD-460B-8BE5-EB2884A71817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F86E-243C-45D0-95FC-F792BB02A30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D6D14-15CD-460B-8BE5-EB2884A71817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F86E-243C-45D0-95FC-F792BB02A30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D6D14-15CD-460B-8BE5-EB2884A71817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F86E-243C-45D0-95FC-F792BB02A30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D6D14-15CD-460B-8BE5-EB2884A71817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F86E-243C-45D0-95FC-F792BB02A30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D6D14-15CD-460B-8BE5-EB2884A71817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F86E-243C-45D0-95FC-F792BB02A30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D6D14-15CD-460B-8BE5-EB2884A71817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F86E-243C-45D0-95FC-F792BB02A30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D6D14-15CD-460B-8BE5-EB2884A71817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F86E-243C-45D0-95FC-F792BB02A30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D6D14-15CD-460B-8BE5-EB2884A71817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F86E-243C-45D0-95FC-F792BB02A30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D6D14-15CD-460B-8BE5-EB2884A71817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F86E-243C-45D0-95FC-F792BB02A30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D6D14-15CD-460B-8BE5-EB2884A71817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F86E-243C-45D0-95FC-F792BB02A30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D6D14-15CD-460B-8BE5-EB2884A71817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F86E-243C-45D0-95FC-F792BB02A30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CD6D14-15CD-460B-8BE5-EB2884A71817}" type="datetimeFigureOut">
              <a:rPr lang="zh-CN" altLang="en-US" smtClean="0"/>
              <a:t>2018/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3FF86E-243C-45D0-95FC-F792BB02A30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/>
          <p:nvPr/>
        </p:nvGraphicFramePr>
        <p:xfrm>
          <a:off x="2011363" y="1219200"/>
          <a:ext cx="5296713" cy="472987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89314"/>
                <a:gridCol w="4507399"/>
              </a:tblGrid>
              <a:tr h="37358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Genes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Primers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7358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ISL1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Right primer sequence: TCACGAAGTCGTTCTTGCTG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0978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ISL1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Left primer sequence:  CATGCTTTGTTAGGGATGGG 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0978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IGFBP3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Right primer sequence: GACGGGCTCTCCACACTG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0978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IGFBP3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Left primer sequence:  AACGCTAGTGCCGTCAGC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0978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GDF6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 dirty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Right primer sequence: CCCACCAGCTCTTCTTTGTC </a:t>
                      </a:r>
                      <a:endParaRPr lang="zh-CN" altLang="en-US" sz="1100" b="0" dirty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0978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GDF6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Left primer sequence:  ACCAGCTTTGTAGACAGGG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0314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TGFB1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Right primer sequence: CTTCCAGCCGAGGTCCTT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0978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TGFB1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Left primer sequence:  CCCTGGACACCAACTATTGC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0978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GAS6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Right primer sequence: CGAAGCCTGAGTTTTTGGTG 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0978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GAS6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Left primer sequence:  GTTCGAGAACGACCCCG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0978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INHBA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Right primer sequence: ATCTCGAAGTGCAGCGTCTT 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7358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INHBA</a:t>
                      </a:r>
                      <a:endParaRPr lang="zh-CN" altLang="en-US" sz="1100" b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zh-CN" sz="1100" b="0" dirty="0">
                          <a:solidFill>
                            <a:srgbClr val="000000"/>
                          </a:solidFill>
                          <a:latin typeface="Arial Unicode MS" panose="020B0604020202020204" charset="-122"/>
                          <a:ea typeface="Arial Unicode MS" panose="020B0604020202020204" charset="-122"/>
                          <a:cs typeface="Arial Unicode MS" panose="020B0604020202020204" charset="-122"/>
                        </a:rPr>
                        <a:t>Left primer sequence:  GGAGGGCAGAAATGAATGAA</a:t>
                      </a:r>
                      <a:endParaRPr lang="zh-CN" altLang="en-US" sz="1100" b="0" dirty="0">
                        <a:solidFill>
                          <a:srgbClr val="000000"/>
                        </a:solidFill>
                        <a:latin typeface="Arial Unicode MS" panose="020B0604020202020204" charset="-122"/>
                        <a:ea typeface="Arial Unicode MS" panose="020B0604020202020204" charset="-122"/>
                        <a:cs typeface="Arial Unicode MS" panose="020B0604020202020204" charset="-122"/>
                      </a:endParaRPr>
                    </a:p>
                  </a:txBody>
                  <a:tcPr marL="0" marR="0" marT="0" marB="1" anchor="ctr">
                    <a:lnL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9501" name="文本框 1"/>
          <p:cNvSpPr txBox="1">
            <a:spLocks noChangeArrowheads="1"/>
          </p:cNvSpPr>
          <p:nvPr/>
        </p:nvSpPr>
        <p:spPr bwMode="auto">
          <a:xfrm>
            <a:off x="4067175" y="584200"/>
            <a:ext cx="2722563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/>
              <a:t>Tab. S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表格 7"/>
          <p:cNvGraphicFramePr>
            <a:graphicFrameLocks noGrp="1"/>
          </p:cNvGraphicFramePr>
          <p:nvPr/>
        </p:nvGraphicFramePr>
        <p:xfrm>
          <a:off x="1044575" y="2060575"/>
          <a:ext cx="7272200" cy="2448064"/>
        </p:xfrm>
        <a:graphic>
          <a:graphicData uri="http://schemas.openxmlformats.org/drawingml/2006/table">
            <a:tbl>
              <a:tblPr/>
              <a:tblGrid>
                <a:gridCol w="2448430"/>
                <a:gridCol w="1274462"/>
                <a:gridCol w="1288166"/>
                <a:gridCol w="1274462"/>
                <a:gridCol w="986680"/>
              </a:tblGrid>
              <a:tr h="309675"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400" b="0" i="0" u="none" strike="noStrike" dirty="0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Ctrl-hMSC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ISL1-hMSC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</a:tr>
              <a:tr h="5900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Ite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Coun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Percentag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latin typeface="Arial" panose="020B06040202020202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Coun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Percentag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latin typeface="Arial" panose="020B06040202020202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96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Raw Read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34,616,4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10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33,120,29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10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096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Clean Read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33,473,1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96.7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32,016,39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96.67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096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Low-quality Read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224,37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0.65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215,68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0.65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096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Adapter Read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672,27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1.94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651,2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1.97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096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Ns Read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246,64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0.71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237,0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0.72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1554" name="文本框 1"/>
          <p:cNvSpPr txBox="1">
            <a:spLocks noChangeArrowheads="1"/>
          </p:cNvSpPr>
          <p:nvPr/>
        </p:nvSpPr>
        <p:spPr bwMode="auto">
          <a:xfrm>
            <a:off x="4067175" y="1125538"/>
            <a:ext cx="2722563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/>
              <a:t>Tab. S2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755650" y="1773238"/>
          <a:ext cx="7488207" cy="2930844"/>
        </p:xfrm>
        <a:graphic>
          <a:graphicData uri="http://schemas.openxmlformats.org/drawingml/2006/table">
            <a:tbl>
              <a:tblPr/>
              <a:tblGrid>
                <a:gridCol w="2394796"/>
                <a:gridCol w="1434198"/>
                <a:gridCol w="1259948"/>
                <a:gridCol w="1434198"/>
                <a:gridCol w="965067"/>
              </a:tblGrid>
              <a:tr h="268755"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400" b="0" i="0" u="none" strike="noStrike" dirty="0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Ctrl-hMSC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ISL1-hMSC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</a:tr>
              <a:tr h="5120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Ite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Coun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Percentag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latin typeface="Arial" panose="020B06040202020202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Coun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Percentag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latin typeface="Arial" panose="020B0604020202020204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87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Total Read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334,73,1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10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32,016,39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10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687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Total BasePai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4,184,140,5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10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4,002,048,75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10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87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Total Mapped Read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31,860,08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95.18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30,477,6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95.19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87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Coding Match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16,303,18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48.71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14,085,0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43.99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87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UTR Match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9,176,4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27.41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9,459,3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29.55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87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Intronic Match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9,176,4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3.77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1,168,06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3.65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87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Intergenic Match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5,119,7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15.3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5,765,22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18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87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mRNA Match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25,479,6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78.12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23,544,32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latin typeface="Arial" panose="020B0604020202020204"/>
                        </a:rPr>
                        <a:t>77.25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3620" name="文本框 1"/>
          <p:cNvSpPr txBox="1">
            <a:spLocks noChangeArrowheads="1"/>
          </p:cNvSpPr>
          <p:nvPr/>
        </p:nvSpPr>
        <p:spPr bwMode="auto">
          <a:xfrm>
            <a:off x="4067175" y="1125538"/>
            <a:ext cx="2722563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/>
              <a:t>Tab. S3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714375" y="44450"/>
          <a:ext cx="8249778" cy="6758886"/>
        </p:xfrm>
        <a:graphic>
          <a:graphicData uri="http://schemas.openxmlformats.org/drawingml/2006/table">
            <a:tbl>
              <a:tblPr/>
              <a:tblGrid>
                <a:gridCol w="1374963"/>
                <a:gridCol w="1374963"/>
                <a:gridCol w="1374963"/>
                <a:gridCol w="1374963"/>
                <a:gridCol w="1374963"/>
                <a:gridCol w="1374963"/>
              </a:tblGrid>
              <a:tr h="21266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err="1">
                          <a:latin typeface="Arial" panose="020B0604020202020204"/>
                        </a:rPr>
                        <a:t>GeneID</a:t>
                      </a:r>
                      <a:endParaRPr lang="en-US" sz="1200" b="0" i="0" u="none" strike="noStrike" dirty="0">
                        <a:latin typeface="Arial" panose="020B0604020202020204"/>
                      </a:endParaRP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latin typeface="Arial" panose="020B0604020202020204"/>
                        </a:rPr>
                        <a:t>MSC(log2)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latin typeface="Arial" panose="020B0604020202020204"/>
                        </a:rPr>
                        <a:t>ISL1(log2)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latin typeface="Arial" panose="020B0604020202020204"/>
                        </a:rPr>
                        <a:t>MSC RPKM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latin typeface="Arial" panose="020B0604020202020204"/>
                        </a:rPr>
                        <a:t>ISL1 RPKM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latin typeface="Arial" panose="020B0604020202020204"/>
                        </a:rPr>
                        <a:t>F</a:t>
                      </a:r>
                      <a:r>
                        <a:rPr lang="en-US" sz="1200" b="0" i="0" u="none" strike="noStrike" dirty="0">
                          <a:latin typeface="宋体" panose="02010600030101010101" pitchFamily="2" charset="-122"/>
                        </a:rPr>
                        <a:t>old</a:t>
                      </a:r>
                      <a:endParaRPr lang="en-US" sz="1200" b="0" i="0" u="none" strike="noStrike" dirty="0">
                        <a:latin typeface="Arial" panose="020B0604020202020204"/>
                      </a:endParaRP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GDF6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8317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4.3965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779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1.061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latin typeface="Arial" panose="020B0604020202020204"/>
                        </a:rPr>
                        <a:t>11.833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Arial" panose="020B0604020202020204"/>
                        </a:rPr>
                        <a:t>IGFBP3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latin typeface="Arial" panose="020B0604020202020204"/>
                        </a:rPr>
                        <a:t>7.5973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latin typeface="Arial" panose="020B0604020202020204"/>
                        </a:rPr>
                        <a:t>9.585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latin typeface="Arial" panose="020B0604020202020204"/>
                        </a:rPr>
                        <a:t>193.6501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latin typeface="Arial" panose="020B0604020202020204"/>
                        </a:rPr>
                        <a:t>768.482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latin typeface="Arial" panose="020B0604020202020204"/>
                        </a:rPr>
                        <a:t>3.968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TGFB1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6.906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8.061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20.003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67.214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.2267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GAS6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7.4233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8.065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71.645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67.8722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560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INHBA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5.110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5.717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34.545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52.5987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522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DNASE1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334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921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260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894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502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SRGN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4.577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5.0512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3.8817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33.1565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388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TNFRSF1A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6.351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6.7601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81.6505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08.394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3275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CST3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6.3605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6.749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82.167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07.556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309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LGALS1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2.4497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2.8092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5594.1361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7177.0952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283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IL12A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3492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6292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273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5467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2141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AIMP1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3.2252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3.4611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9.351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1.012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177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GREM1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9.089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9.2201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544.7175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596.3822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094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ITM2B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6.0277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6.0951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65.241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68.360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047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FAS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3.080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3.1412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8.459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8.822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042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TNFSF12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3.642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3.579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2.4905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1.954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957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KITLG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.8933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.723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7.429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6.6062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8891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C6orf120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3.786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3.611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3.800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2.221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885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LY96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.0391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7485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4.109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3.3602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817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SEMA3A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4.498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4.0815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2.602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6.929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749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CYR61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6.8451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6.4095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14.9723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85.0037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7393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GSN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6.4957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6.0422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90.2391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65.901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7303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CLU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5.768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5.265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54.522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38.4737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705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WNT7B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910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389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879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3101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697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DNAJC10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3.6323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3.079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2.399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8.453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681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NGF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.107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421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4.307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.6792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621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TNFRSF25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454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635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.740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554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5671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TNFRSF11B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4.735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3.372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6.640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0.359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388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IL6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003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-0.380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.005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768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383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SLIT2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3.5385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.118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1.619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4.3437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373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ADAMTSL4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.2741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814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4.836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7591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latin typeface="Arial" panose="020B0604020202020204"/>
                        </a:rPr>
                        <a:t>0.3637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IL1B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.9582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2797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7.7717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.4279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3124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 panose="020B0604020202020204"/>
                        </a:rPr>
                        <a:t>SLIT3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1.065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-1.2947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2.093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407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latin typeface="Arial" panose="020B0604020202020204"/>
                        </a:rPr>
                        <a:t>0.1947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53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latin typeface="Arial" panose="020B0604020202020204"/>
                        </a:rPr>
                        <a:t>TNFRSF1B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latin typeface="Arial" panose="020B0604020202020204"/>
                        </a:rPr>
                        <a:t>3.0006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latin typeface="Arial" panose="020B0604020202020204"/>
                        </a:rPr>
                        <a:t>-0.6670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latin typeface="Arial" panose="020B0604020202020204"/>
                        </a:rPr>
                        <a:t>8.0031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latin typeface="Arial" panose="020B0604020202020204"/>
                        </a:rPr>
                        <a:t>0.6298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latin typeface="Arial" panose="020B0604020202020204"/>
                        </a:rPr>
                        <a:t>0.0787 </a:t>
                      </a:r>
                    </a:p>
                  </a:txBody>
                  <a:tcPr marL="6100" marR="6100" marT="61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25855" name="文本框 1"/>
          <p:cNvSpPr txBox="1">
            <a:spLocks noChangeArrowheads="1"/>
          </p:cNvSpPr>
          <p:nvPr/>
        </p:nvSpPr>
        <p:spPr bwMode="auto">
          <a:xfrm>
            <a:off x="-36513" y="-26988"/>
            <a:ext cx="900113" cy="3079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400"/>
              <a:t>Tab. S4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6</Words>
  <Application>Microsoft Office PowerPoint</Application>
  <PresentationFormat>全屏显示(4:3)</PresentationFormat>
  <Paragraphs>328</Paragraphs>
  <Slides>4</Slides>
  <Notes>4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幻灯片 1</vt:lpstr>
      <vt:lpstr>幻灯片 2</vt:lpstr>
      <vt:lpstr>幻灯片 3</vt:lpstr>
      <vt:lpstr>幻灯片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dministrator</cp:lastModifiedBy>
  <cp:revision>1</cp:revision>
  <dcterms:created xsi:type="dcterms:W3CDTF">2018-02-08T07:34:52Z</dcterms:created>
  <dcterms:modified xsi:type="dcterms:W3CDTF">2018-02-08T07:35:14Z</dcterms:modified>
</cp:coreProperties>
</file>